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9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11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9FBB2A-1BF9-4BAE-881D-636A80BF3BF3}" type="datetimeFigureOut">
              <a:rPr lang="en-US" smtClean="0"/>
              <a:t>8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BA1793-354E-423E-A153-1A2083796E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49698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9FBB2A-1BF9-4BAE-881D-636A80BF3BF3}" type="datetimeFigureOut">
              <a:rPr lang="en-US" smtClean="0"/>
              <a:t>8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BA1793-354E-423E-A153-1A2083796E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36894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9FBB2A-1BF9-4BAE-881D-636A80BF3BF3}" type="datetimeFigureOut">
              <a:rPr lang="en-US" smtClean="0"/>
              <a:t>8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BA1793-354E-423E-A153-1A2083796E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05549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9FBB2A-1BF9-4BAE-881D-636A80BF3BF3}" type="datetimeFigureOut">
              <a:rPr lang="en-US" smtClean="0"/>
              <a:t>8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BA1793-354E-423E-A153-1A2083796E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88749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9FBB2A-1BF9-4BAE-881D-636A80BF3BF3}" type="datetimeFigureOut">
              <a:rPr lang="en-US" smtClean="0"/>
              <a:t>8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BA1793-354E-423E-A153-1A2083796E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33502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9FBB2A-1BF9-4BAE-881D-636A80BF3BF3}" type="datetimeFigureOut">
              <a:rPr lang="en-US" smtClean="0"/>
              <a:t>8/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BA1793-354E-423E-A153-1A2083796E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81868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9FBB2A-1BF9-4BAE-881D-636A80BF3BF3}" type="datetimeFigureOut">
              <a:rPr lang="en-US" smtClean="0"/>
              <a:t>8/1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BA1793-354E-423E-A153-1A2083796E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24577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9FBB2A-1BF9-4BAE-881D-636A80BF3BF3}" type="datetimeFigureOut">
              <a:rPr lang="en-US" smtClean="0"/>
              <a:t>8/1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BA1793-354E-423E-A153-1A2083796E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49306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9FBB2A-1BF9-4BAE-881D-636A80BF3BF3}" type="datetimeFigureOut">
              <a:rPr lang="en-US" smtClean="0"/>
              <a:t>8/1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BA1793-354E-423E-A153-1A2083796E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68453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9FBB2A-1BF9-4BAE-881D-636A80BF3BF3}" type="datetimeFigureOut">
              <a:rPr lang="en-US" smtClean="0"/>
              <a:t>8/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BA1793-354E-423E-A153-1A2083796E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82481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9FBB2A-1BF9-4BAE-881D-636A80BF3BF3}" type="datetimeFigureOut">
              <a:rPr lang="en-US" smtClean="0"/>
              <a:t>8/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BA1793-354E-423E-A153-1A2083796E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1004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9FBB2A-1BF9-4BAE-881D-636A80BF3BF3}" type="datetimeFigureOut">
              <a:rPr lang="en-US" smtClean="0"/>
              <a:t>8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BA1793-354E-423E-A153-1A2083796E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89308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A6F58448-CE73-4625-BB56-79AE88DE15C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46153" y="219134"/>
            <a:ext cx="2670575" cy="4005863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456B4662-42A1-4C75-9EDF-412141F36F9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2704" b="22534"/>
          <a:stretch/>
        </p:blipFill>
        <p:spPr>
          <a:xfrm>
            <a:off x="6408420" y="190499"/>
            <a:ext cx="3412196" cy="2802876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CC27B80A-CE49-4BB4-8C3F-5ECE4B726F3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08420" y="3436094"/>
            <a:ext cx="3421425" cy="3224693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B399B599-39C0-40E3-8BAC-209CD95BD521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2708" b="8334"/>
          <a:stretch/>
        </p:blipFill>
        <p:spPr>
          <a:xfrm>
            <a:off x="76155" y="4389158"/>
            <a:ext cx="4321028" cy="2298945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0F9B2D51-F74F-4B53-950E-3A88A6C9F031}"/>
              </a:ext>
            </a:extLst>
          </p:cNvPr>
          <p:cNvCxnSpPr>
            <a:cxnSpLocks/>
          </p:cNvCxnSpPr>
          <p:nvPr/>
        </p:nvCxnSpPr>
        <p:spPr>
          <a:xfrm>
            <a:off x="5303521" y="1706767"/>
            <a:ext cx="1104899" cy="0"/>
          </a:xfrm>
          <a:prstGeom prst="straightConnector1">
            <a:avLst/>
          </a:prstGeom>
          <a:ln w="44450" cmpd="sng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927B516D-8882-49B4-A23D-77237C611FF1}"/>
              </a:ext>
            </a:extLst>
          </p:cNvPr>
          <p:cNvCxnSpPr>
            <a:cxnSpLocks/>
          </p:cNvCxnSpPr>
          <p:nvPr/>
        </p:nvCxnSpPr>
        <p:spPr>
          <a:xfrm>
            <a:off x="5120640" y="3255359"/>
            <a:ext cx="1287780" cy="648980"/>
          </a:xfrm>
          <a:prstGeom prst="straightConnector1">
            <a:avLst/>
          </a:prstGeom>
          <a:ln w="44450" cmpd="sng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4143E5FF-1B18-4DA4-A82B-5C2145CA631E}"/>
              </a:ext>
            </a:extLst>
          </p:cNvPr>
          <p:cNvCxnSpPr>
            <a:cxnSpLocks/>
          </p:cNvCxnSpPr>
          <p:nvPr/>
        </p:nvCxnSpPr>
        <p:spPr>
          <a:xfrm flipH="1">
            <a:off x="2939178" y="3848380"/>
            <a:ext cx="459342" cy="521056"/>
          </a:xfrm>
          <a:prstGeom prst="straightConnector1">
            <a:avLst/>
          </a:prstGeom>
          <a:ln w="44450" cmpd="sng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Rectangle 27">
            <a:extLst>
              <a:ext uri="{FF2B5EF4-FFF2-40B4-BE49-F238E27FC236}">
                <a16:creationId xmlns:a16="http://schemas.microsoft.com/office/drawing/2014/main" id="{74114E8C-03F4-47C8-B8FB-077F2F8B606F}"/>
              </a:ext>
            </a:extLst>
          </p:cNvPr>
          <p:cNvSpPr/>
          <p:nvPr/>
        </p:nvSpPr>
        <p:spPr>
          <a:xfrm>
            <a:off x="3398520" y="3311318"/>
            <a:ext cx="975803" cy="537062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48D75506-739D-4A9E-915D-F386FF52077A}"/>
              </a:ext>
            </a:extLst>
          </p:cNvPr>
          <p:cNvSpPr/>
          <p:nvPr/>
        </p:nvSpPr>
        <p:spPr>
          <a:xfrm>
            <a:off x="4767149" y="2993375"/>
            <a:ext cx="371702" cy="357088"/>
          </a:xfrm>
          <a:prstGeom prst="rect">
            <a:avLst/>
          </a:prstGeom>
          <a:noFill/>
          <a:ln w="127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20D919A8-1A11-4CB9-BAB4-D3DAB7925363}"/>
              </a:ext>
            </a:extLst>
          </p:cNvPr>
          <p:cNvSpPr/>
          <p:nvPr/>
        </p:nvSpPr>
        <p:spPr>
          <a:xfrm>
            <a:off x="4767149" y="1546860"/>
            <a:ext cx="536372" cy="35708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2A1BB933-0BE4-4666-BBE4-C47375E82678}"/>
              </a:ext>
            </a:extLst>
          </p:cNvPr>
          <p:cNvSpPr txBox="1"/>
          <p:nvPr/>
        </p:nvSpPr>
        <p:spPr>
          <a:xfrm>
            <a:off x="211218" y="219134"/>
            <a:ext cx="272796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400" b="1" dirty="0">
                <a:latin typeface="Palatino Linotype" panose="02040502050505030304" pitchFamily="18" charset="0"/>
              </a:rPr>
              <a:t>Supplementary Figure S1. </a:t>
            </a:r>
            <a:r>
              <a:rPr lang="en-US" sz="1400" dirty="0"/>
              <a:t>Distribution of </a:t>
            </a:r>
            <a:r>
              <a:rPr lang="en-US" sz="1400" dirty="0" err="1"/>
              <a:t>AanI</a:t>
            </a:r>
            <a:r>
              <a:rPr lang="en-US" sz="1400" dirty="0"/>
              <a:t> </a:t>
            </a:r>
            <a:r>
              <a:rPr lang="en-US" sz="1400" dirty="0" err="1"/>
              <a:t>restrictotypes</a:t>
            </a:r>
            <a:r>
              <a:rPr lang="en-US" sz="1400" dirty="0"/>
              <a:t> of AsMaV-RNA3 on a Geographical Map.</a:t>
            </a:r>
            <a:endParaRPr lang="en-GB" sz="14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845554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5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aheen</dc:creator>
  <cp:lastModifiedBy>MDPI</cp:lastModifiedBy>
  <cp:revision>5</cp:revision>
  <dcterms:created xsi:type="dcterms:W3CDTF">2023-07-29T10:38:21Z</dcterms:created>
  <dcterms:modified xsi:type="dcterms:W3CDTF">2023-08-01T03:12:01Z</dcterms:modified>
</cp:coreProperties>
</file>